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62" r:id="rId3"/>
    <p:sldId id="260" r:id="rId4"/>
    <p:sldId id="257" r:id="rId5"/>
    <p:sldId id="258" r:id="rId6"/>
    <p:sldId id="259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67" d="100"/>
          <a:sy n="67" d="100"/>
        </p:scale>
        <p:origin x="96" y="1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D9C3DB-C2CA-444E-A268-CF71998C2762}" type="datetimeFigureOut">
              <a:rPr lang="en-US" smtClean="0"/>
              <a:t>4/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251464-A2BF-40BB-B276-C1BA5EC89D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29279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D9C3DB-C2CA-444E-A268-CF71998C2762}" type="datetimeFigureOut">
              <a:rPr lang="en-US" smtClean="0"/>
              <a:t>4/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251464-A2BF-40BB-B276-C1BA5EC89D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42057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D9C3DB-C2CA-444E-A268-CF71998C2762}" type="datetimeFigureOut">
              <a:rPr lang="en-US" smtClean="0"/>
              <a:t>4/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251464-A2BF-40BB-B276-C1BA5EC89D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295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D9C3DB-C2CA-444E-A268-CF71998C2762}" type="datetimeFigureOut">
              <a:rPr lang="en-US" smtClean="0"/>
              <a:t>4/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251464-A2BF-40BB-B276-C1BA5EC89D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70156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D9C3DB-C2CA-444E-A268-CF71998C2762}" type="datetimeFigureOut">
              <a:rPr lang="en-US" smtClean="0"/>
              <a:t>4/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251464-A2BF-40BB-B276-C1BA5EC89D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03474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D9C3DB-C2CA-444E-A268-CF71998C2762}" type="datetimeFigureOut">
              <a:rPr lang="en-US" smtClean="0"/>
              <a:t>4/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251464-A2BF-40BB-B276-C1BA5EC89D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89862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D9C3DB-C2CA-444E-A268-CF71998C2762}" type="datetimeFigureOut">
              <a:rPr lang="en-US" smtClean="0"/>
              <a:t>4/5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251464-A2BF-40BB-B276-C1BA5EC89D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686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D9C3DB-C2CA-444E-A268-CF71998C2762}" type="datetimeFigureOut">
              <a:rPr lang="en-US" smtClean="0"/>
              <a:t>4/5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251464-A2BF-40BB-B276-C1BA5EC89D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91845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D9C3DB-C2CA-444E-A268-CF71998C2762}" type="datetimeFigureOut">
              <a:rPr lang="en-US" smtClean="0"/>
              <a:t>4/5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251464-A2BF-40BB-B276-C1BA5EC89D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53176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D9C3DB-C2CA-444E-A268-CF71998C2762}" type="datetimeFigureOut">
              <a:rPr lang="en-US" smtClean="0"/>
              <a:t>4/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251464-A2BF-40BB-B276-C1BA5EC89D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08722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D9C3DB-C2CA-444E-A268-CF71998C2762}" type="datetimeFigureOut">
              <a:rPr lang="en-US" smtClean="0"/>
              <a:t>4/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251464-A2BF-40BB-B276-C1BA5EC89D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70286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D9C3DB-C2CA-444E-A268-CF71998C2762}" type="datetimeFigureOut">
              <a:rPr lang="en-US" smtClean="0"/>
              <a:t>4/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251464-A2BF-40BB-B276-C1BA5EC89D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96545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microsoft.com/office/2007/relationships/hdphoto" Target="../media/hdphoto2.wdp"/><Relationship Id="rId4" Type="http://schemas.openxmlformats.org/officeDocument/2006/relationships/image" Target="../media/image4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E8EC1DF2-DEA0-48F9-9165-B641FD5F92C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43000" y="1247246"/>
            <a:ext cx="10236301" cy="5396441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523498A0-A619-481D-9D5C-FBCFFEEC3011}"/>
              </a:ext>
            </a:extLst>
          </p:cNvPr>
          <p:cNvSpPr/>
          <p:nvPr/>
        </p:nvSpPr>
        <p:spPr>
          <a:xfrm>
            <a:off x="0" y="0"/>
            <a:ext cx="12072938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1a </a:t>
            </a:r>
            <a:r>
              <a:rPr lang="en-US" sz="1400" b="1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x vivo</a:t>
            </a:r>
            <a:r>
              <a:rPr lang="en-US" sz="14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Ixazomib response and clinical follow-up data in myeloma patients</a:t>
            </a: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Bar Graphs represent the AUSC values of patient-derived CD138+ cells treated with the proteasome inhibitor drug Ixazomib. Patients with favorable clinical responses are represented with CR/VGPR/PR based on follow-up data (CR- Complete response; VGPR- Very good partial response; PR- Partial response).</a:t>
            </a: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A181FAB1-151F-4C0A-A515-BABC860FF3EA}"/>
              </a:ext>
            </a:extLst>
          </p:cNvPr>
          <p:cNvSpPr/>
          <p:nvPr/>
        </p:nvSpPr>
        <p:spPr>
          <a:xfrm>
            <a:off x="6883875" y="3482008"/>
            <a:ext cx="38023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dirty="0">
                <a:cs typeface="Arial" panose="020B0604020202020204" pitchFamily="34" charset="0"/>
              </a:rPr>
              <a:t>CR</a:t>
            </a:r>
            <a:endParaRPr lang="en-US" sz="1400" b="1" dirty="0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531FF3EA-626B-489C-A87C-CC5935AE27C4}"/>
              </a:ext>
            </a:extLst>
          </p:cNvPr>
          <p:cNvSpPr/>
          <p:nvPr/>
        </p:nvSpPr>
        <p:spPr>
          <a:xfrm>
            <a:off x="5764067" y="3581400"/>
            <a:ext cx="38023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dirty="0">
                <a:cs typeface="Arial" panose="020B0604020202020204" pitchFamily="34" charset="0"/>
              </a:rPr>
              <a:t>CR</a:t>
            </a:r>
            <a:endParaRPr lang="en-US" sz="1400" b="1" dirty="0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7BAF6F73-0CDD-443F-BFFD-24976B8B9F93}"/>
              </a:ext>
            </a:extLst>
          </p:cNvPr>
          <p:cNvSpPr/>
          <p:nvPr/>
        </p:nvSpPr>
        <p:spPr>
          <a:xfrm>
            <a:off x="4584627" y="3700668"/>
            <a:ext cx="38023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dirty="0">
                <a:cs typeface="Arial" panose="020B0604020202020204" pitchFamily="34" charset="0"/>
              </a:rPr>
              <a:t>CR</a:t>
            </a:r>
            <a:endParaRPr lang="en-US" sz="1400" b="1" dirty="0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9EFC78E4-B741-4A84-AF00-50A7E82D1C85}"/>
              </a:ext>
            </a:extLst>
          </p:cNvPr>
          <p:cNvSpPr/>
          <p:nvPr/>
        </p:nvSpPr>
        <p:spPr>
          <a:xfrm>
            <a:off x="3411811" y="3760304"/>
            <a:ext cx="38183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dirty="0">
                <a:cs typeface="Arial" panose="020B0604020202020204" pitchFamily="34" charset="0"/>
              </a:rPr>
              <a:t>PR</a:t>
            </a:r>
            <a:endParaRPr lang="en-US" sz="1400" b="1" dirty="0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97560234-E856-4407-A1F7-E88EC4749319}"/>
              </a:ext>
            </a:extLst>
          </p:cNvPr>
          <p:cNvSpPr/>
          <p:nvPr/>
        </p:nvSpPr>
        <p:spPr>
          <a:xfrm>
            <a:off x="2159484" y="4694579"/>
            <a:ext cx="598369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dirty="0">
                <a:cs typeface="Arial" panose="020B0604020202020204" pitchFamily="34" charset="0"/>
              </a:rPr>
              <a:t>VGPR</a:t>
            </a:r>
            <a:endParaRPr 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8441213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09AA70F2-1745-4941-AB65-341FE208CA2D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8112"/>
          <a:stretch/>
        </p:blipFill>
        <p:spPr>
          <a:xfrm>
            <a:off x="2266950" y="1114426"/>
            <a:ext cx="8029575" cy="5610224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806950CB-AD3C-4F9B-A211-D2CF0A2433A3}"/>
              </a:ext>
            </a:extLst>
          </p:cNvPr>
          <p:cNvSpPr/>
          <p:nvPr/>
        </p:nvSpPr>
        <p:spPr>
          <a:xfrm>
            <a:off x="228600" y="375762"/>
            <a:ext cx="11801475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1b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Kaplan-Meier plots showing stratification in progression-free survival (PFS) among MM patients grouped as </a:t>
            </a:r>
            <a:r>
              <a:rPr lang="en-US" sz="1400">
                <a:latin typeface="Arial" panose="020B0604020202020204" pitchFamily="34" charset="0"/>
                <a:cs typeface="Arial" panose="020B0604020202020204" pitchFamily="34" charset="0"/>
              </a:rPr>
              <a:t>PI-resistant or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PI-sensitive based on ex vivo PI-sensitivity of patient-derived CD138+ cells treated with the proteasome inhibitor drug Ixazomib.</a:t>
            </a:r>
          </a:p>
        </p:txBody>
      </p:sp>
    </p:spTree>
    <p:extLst>
      <p:ext uri="{BB962C8B-B14F-4D97-AF65-F5344CB8AC3E}">
        <p14:creationId xmlns:p14="http://schemas.microsoft.com/office/powerpoint/2010/main" val="35516778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  <a14:imgEffect>
                      <a14:brightnessContrast contrast="-40000"/>
                    </a14:imgEffect>
                  </a14:imgLayer>
                </a14:imgProps>
              </a:ext>
            </a:extLst>
          </a:blip>
          <a:srcRect l="16113" r="17779"/>
          <a:stretch/>
        </p:blipFill>
        <p:spPr>
          <a:xfrm>
            <a:off x="317500" y="1678980"/>
            <a:ext cx="3822700" cy="367755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" name="Rectangle 5"/>
          <p:cNvSpPr/>
          <p:nvPr/>
        </p:nvSpPr>
        <p:spPr>
          <a:xfrm>
            <a:off x="196451" y="1309034"/>
            <a:ext cx="36580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a)</a:t>
            </a: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</a14:imgLayer>
                </a14:imgProps>
              </a:ext>
            </a:extLst>
          </a:blip>
          <a:srcRect l="18538" r="19081"/>
          <a:stretch/>
        </p:blipFill>
        <p:spPr>
          <a:xfrm>
            <a:off x="4270944" y="1678366"/>
            <a:ext cx="3835401" cy="367816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" name="Rectangle 7"/>
          <p:cNvSpPr/>
          <p:nvPr/>
        </p:nvSpPr>
        <p:spPr>
          <a:xfrm>
            <a:off x="4261249" y="1309034"/>
            <a:ext cx="37702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b)</a:t>
            </a:r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harpenSoften amount="50000"/>
                    </a14:imgEffect>
                  </a14:imgLayer>
                </a14:imgProps>
              </a:ext>
            </a:extLst>
          </a:blip>
          <a:srcRect l="18326" r="18326"/>
          <a:stretch/>
        </p:blipFill>
        <p:spPr>
          <a:xfrm>
            <a:off x="8227394" y="1690688"/>
            <a:ext cx="3882466" cy="366645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0" name="Rectangle 9"/>
          <p:cNvSpPr/>
          <p:nvPr/>
        </p:nvSpPr>
        <p:spPr>
          <a:xfrm>
            <a:off x="8227394" y="1309034"/>
            <a:ext cx="35298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c)</a:t>
            </a:r>
          </a:p>
        </p:txBody>
      </p:sp>
      <p:sp>
        <p:nvSpPr>
          <p:cNvPr id="11" name="Rectangle 10"/>
          <p:cNvSpPr/>
          <p:nvPr/>
        </p:nvSpPr>
        <p:spPr>
          <a:xfrm>
            <a:off x="217996" y="157877"/>
            <a:ext cx="11974004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2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Volcano plot representing p-values of differential gene expression analysis between treated and Ixazomib-untreated myeloma cell lines in a) 12 myeloma cell lines (6 sensitive, 6 resistant); b)  6 sensitive lines only; c) 6 resistant lines only. Prior to analysis, gene expression values were filtered, samples with mean FPKM &lt;1 or max FPKM &lt;1 were removed, and z-score normalized.</a:t>
            </a:r>
          </a:p>
        </p:txBody>
      </p:sp>
    </p:spTree>
    <p:extLst>
      <p:ext uri="{BB962C8B-B14F-4D97-AF65-F5344CB8AC3E}">
        <p14:creationId xmlns:p14="http://schemas.microsoft.com/office/powerpoint/2010/main" val="298191719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/>
          <p:cNvSpPr/>
          <p:nvPr/>
        </p:nvSpPr>
        <p:spPr>
          <a:xfrm>
            <a:off x="104775" y="67936"/>
            <a:ext cx="12087225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3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Ingenuity Pathway analysis results</a:t>
            </a: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The top five (5) canonical pathways based on most significant kinetic gene expression signatures common between cell lines and patients, unique in</a:t>
            </a: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) Ix-sensitive; b) Ix-resistance</a:t>
            </a:r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363" r="5577" b="9571"/>
          <a:stretch/>
        </p:blipFill>
        <p:spPr>
          <a:xfrm>
            <a:off x="372446" y="1891987"/>
            <a:ext cx="4399861" cy="302718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" name="TextBox 3"/>
          <p:cNvSpPr txBox="1"/>
          <p:nvPr/>
        </p:nvSpPr>
        <p:spPr>
          <a:xfrm>
            <a:off x="372446" y="1522655"/>
            <a:ext cx="3658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)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5735021" y="1522655"/>
            <a:ext cx="3770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)</a:t>
            </a:r>
          </a:p>
        </p:txBody>
      </p:sp>
      <p:pic>
        <p:nvPicPr>
          <p:cNvPr id="13" name="Picture 1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85" t="12551" r="6753" b="10869"/>
          <a:stretch/>
        </p:blipFill>
        <p:spPr>
          <a:xfrm>
            <a:off x="6112047" y="1891987"/>
            <a:ext cx="5527963" cy="3027180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143101720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32659" y="799401"/>
            <a:ext cx="6319160" cy="5493333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238897" y="163373"/>
            <a:ext cx="11763056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4.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Venn diagrams showing comparison of the kinetic response profile of all the sub-groups (p &lt;0.05) </a:t>
            </a:r>
          </a:p>
        </p:txBody>
      </p:sp>
    </p:spTree>
    <p:extLst>
      <p:ext uri="{BB962C8B-B14F-4D97-AF65-F5344CB8AC3E}">
        <p14:creationId xmlns:p14="http://schemas.microsoft.com/office/powerpoint/2010/main" val="154439810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255373" y="118587"/>
            <a:ext cx="11697730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5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Venn Diagram showing comparison between the gene lists representing kinetic response profiles for Shaughnessy’s post-Bz GEP80 gene signature and  a) ALL cell lines and Patients (p&lt;05); b) Ix-sensitive cell lines and patients (p&lt;05).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85975" y="1242171"/>
            <a:ext cx="4065925" cy="4099029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13407" y="1242171"/>
            <a:ext cx="4192018" cy="4226148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924894" y="949584"/>
            <a:ext cx="38985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  <a:endParaRPr lang="en-US" dirty="0"/>
          </a:p>
        </p:txBody>
      </p:sp>
      <p:sp>
        <p:nvSpPr>
          <p:cNvPr id="10" name="Rectangle 9"/>
          <p:cNvSpPr/>
          <p:nvPr/>
        </p:nvSpPr>
        <p:spPr>
          <a:xfrm>
            <a:off x="6929744" y="950087"/>
            <a:ext cx="40267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119159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1</TotalTime>
  <Words>299</Words>
  <Application>Microsoft Office PowerPoint</Application>
  <PresentationFormat>Widescreen</PresentationFormat>
  <Paragraphs>21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Auburn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mit Kumar Mitra</dc:creator>
  <cp:lastModifiedBy>Amit Mitra</cp:lastModifiedBy>
  <cp:revision>14</cp:revision>
  <dcterms:created xsi:type="dcterms:W3CDTF">2018-08-18T00:57:18Z</dcterms:created>
  <dcterms:modified xsi:type="dcterms:W3CDTF">2020-04-06T04:11:52Z</dcterms:modified>
</cp:coreProperties>
</file>